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68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38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865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4908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738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4619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931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3689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899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488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54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8772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AE8BE-055C-44F0-B6D9-5B43B53DA25C}" type="datetimeFigureOut">
              <a:rPr lang="zh-CN" altLang="en-US" smtClean="0"/>
              <a:t>2017/7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B588B-8975-4610-B4E2-5DDA144638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1250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681" y="933450"/>
            <a:ext cx="1871525" cy="18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7206" y="933450"/>
            <a:ext cx="1896645" cy="18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0843" y="923925"/>
            <a:ext cx="1896645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7325" y="923925"/>
            <a:ext cx="1855142" cy="180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4941" y="923925"/>
            <a:ext cx="1847059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0962" y="923925"/>
            <a:ext cx="1867401" cy="18000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88907" y="304800"/>
            <a:ext cx="5048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865700" y="2733450"/>
            <a:ext cx="5048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282925" y="2733450"/>
            <a:ext cx="5048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0" y="5288340"/>
            <a:ext cx="1225867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2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identification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M-MSC. Flow cytometry analysis was used to identify phenotypes of BM-MSCs. The cells were labeled with the following biomarkers: FITC-conjugated  anti-HLA-DR, anti-CD34, anti-CD45, anti-CD90 and PE-conjugated anti-CD73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CD90. BM-MSCs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ositive for all thre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Cs biomarkers,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t negative for hematological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an-leukocyte and HLA-DR markers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. Multipoten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tion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acity of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-MSC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-MSCs were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d in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teogenic and </a:t>
            </a:r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ipogenic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uction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 for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eks. The differentiated cells were positive by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method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ine phosphatas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teogenic cells (B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il Red O for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ipogenic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. Scale bars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l-GR" altLang="zh-CN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9231" y="3362340"/>
            <a:ext cx="2529840" cy="188976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2627" y="3362340"/>
            <a:ext cx="2529840" cy="1889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9548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</TotalTime>
  <Words>118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n xiao</dc:creator>
  <cp:lastModifiedBy>jun xiao</cp:lastModifiedBy>
  <cp:revision>8</cp:revision>
  <dcterms:created xsi:type="dcterms:W3CDTF">2017-07-05T05:13:43Z</dcterms:created>
  <dcterms:modified xsi:type="dcterms:W3CDTF">2017-07-10T09:26:06Z</dcterms:modified>
</cp:coreProperties>
</file>